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06663E-A365-493C-998E-7647593974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D27E95-A642-45DB-B550-B3869B7A26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36E96B-5C5C-48B9-8A95-B878DD6935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B0524B-2F40-427F-9624-93C27FE310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8A8E85-6CD2-4068-9DAE-8945D64857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0C7979-E20F-4943-A10C-D42E15FDB3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AAC9A-F550-4317-9ABE-25F95FEFEE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D14D4E-37B5-45EB-9099-27DE351B44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97D991-082F-496E-8D77-31FD32A726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6780A-C328-4998-A997-F0B3BB7621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611DEC-FD5F-4463-BEEC-6DC43D5894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5117F6-6671-4A68-B0C8-7117E6AB19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3B4238C-936F-41F8-9AAD-C2DABE361A2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D0F464C-C84B-4060-83EF-D5E0202679F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6306840" y="1009800"/>
            <a:ext cx="2218320" cy="324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a plasmi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a plasmid +  0.01 ng MO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a plasmid + 0.1 ng MO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a plasmid + 1 ng MO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a plasmid + 2 ng MO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a plasmid + 4 ng MO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a plasmid + 0.01 ng MO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a plasmid + 0.1 ng MO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a plasmid + 1 ng MO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J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a plasmid + 2 ng MO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a plasmid + 4 ng MO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b plasmi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b plasmid +  0.01 ng MO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b plasmid + 0.1 ng MO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b plasmid + 1 ng MO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b plasmid + 2 ng MO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Q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b plasmid + 4 ng MO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b plasmid + 0.01 ng MO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b plasmid + 0.1 ng MO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b plasmid + 1 ng MO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b plasmid + 2 ng MO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rc5b plasmid + 4 ng MO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22"/>
          <p:cNvSpPr/>
          <p:nvPr/>
        </p:nvSpPr>
        <p:spPr>
          <a:xfrm>
            <a:off x="638280" y="1089000"/>
            <a:ext cx="5460840" cy="312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23"/>
          <p:cNvSpPr/>
          <p:nvPr/>
        </p:nvSpPr>
        <p:spPr>
          <a:xfrm>
            <a:off x="577800" y="1008000"/>
            <a:ext cx="8005680" cy="3322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24"/>
          <p:cNvSpPr/>
          <p:nvPr/>
        </p:nvSpPr>
        <p:spPr>
          <a:xfrm>
            <a:off x="1335240" y="3419640"/>
            <a:ext cx="4665600" cy="144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25"/>
          <p:cNvSpPr/>
          <p:nvPr/>
        </p:nvSpPr>
        <p:spPr>
          <a:xfrm>
            <a:off x="1335240" y="2992320"/>
            <a:ext cx="4665600" cy="180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26"/>
          <p:cNvSpPr/>
          <p:nvPr/>
        </p:nvSpPr>
        <p:spPr>
          <a:xfrm>
            <a:off x="1335240" y="2565360"/>
            <a:ext cx="4665600" cy="180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27"/>
          <p:cNvSpPr/>
          <p:nvPr/>
        </p:nvSpPr>
        <p:spPr>
          <a:xfrm>
            <a:off x="1335240" y="2138400"/>
            <a:ext cx="4665600" cy="144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28"/>
          <p:cNvSpPr/>
          <p:nvPr/>
        </p:nvSpPr>
        <p:spPr>
          <a:xfrm>
            <a:off x="1335240" y="1709640"/>
            <a:ext cx="4665600" cy="180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29"/>
          <p:cNvSpPr/>
          <p:nvPr/>
        </p:nvSpPr>
        <p:spPr>
          <a:xfrm>
            <a:off x="1335240" y="1282680"/>
            <a:ext cx="4665600" cy="144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30"/>
          <p:cNvSpPr/>
          <p:nvPr/>
        </p:nvSpPr>
        <p:spPr>
          <a:xfrm>
            <a:off x="1395360" y="1446120"/>
            <a:ext cx="81000" cy="2400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31"/>
          <p:cNvSpPr/>
          <p:nvPr/>
        </p:nvSpPr>
        <p:spPr>
          <a:xfrm>
            <a:off x="1596960" y="2233440"/>
            <a:ext cx="84240" cy="1613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32"/>
          <p:cNvSpPr/>
          <p:nvPr/>
        </p:nvSpPr>
        <p:spPr>
          <a:xfrm>
            <a:off x="1801800" y="2725560"/>
            <a:ext cx="81000" cy="1121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33"/>
          <p:cNvSpPr/>
          <p:nvPr/>
        </p:nvSpPr>
        <p:spPr>
          <a:xfrm>
            <a:off x="2003400" y="2851200"/>
            <a:ext cx="82440" cy="9954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34"/>
          <p:cNvSpPr/>
          <p:nvPr/>
        </p:nvSpPr>
        <p:spPr>
          <a:xfrm>
            <a:off x="2206800" y="2867040"/>
            <a:ext cx="82440" cy="9795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35"/>
          <p:cNvSpPr/>
          <p:nvPr/>
        </p:nvSpPr>
        <p:spPr>
          <a:xfrm>
            <a:off x="2409840" y="2811600"/>
            <a:ext cx="82440" cy="10350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36"/>
          <p:cNvSpPr/>
          <p:nvPr/>
        </p:nvSpPr>
        <p:spPr>
          <a:xfrm>
            <a:off x="2612880" y="1522440"/>
            <a:ext cx="81000" cy="2324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37"/>
          <p:cNvSpPr/>
          <p:nvPr/>
        </p:nvSpPr>
        <p:spPr>
          <a:xfrm>
            <a:off x="2814480" y="1523880"/>
            <a:ext cx="82800" cy="23227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38"/>
          <p:cNvSpPr/>
          <p:nvPr/>
        </p:nvSpPr>
        <p:spPr>
          <a:xfrm>
            <a:off x="3017880" y="1606680"/>
            <a:ext cx="82440" cy="2239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39"/>
          <p:cNvSpPr/>
          <p:nvPr/>
        </p:nvSpPr>
        <p:spPr>
          <a:xfrm>
            <a:off x="3220920" y="1895400"/>
            <a:ext cx="82800" cy="19512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140"/>
          <p:cNvSpPr/>
          <p:nvPr/>
        </p:nvSpPr>
        <p:spPr>
          <a:xfrm>
            <a:off x="3424320" y="1871640"/>
            <a:ext cx="81000" cy="19749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141"/>
          <p:cNvSpPr/>
          <p:nvPr/>
        </p:nvSpPr>
        <p:spPr>
          <a:xfrm>
            <a:off x="3830760" y="1908000"/>
            <a:ext cx="81000" cy="19386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142"/>
          <p:cNvSpPr/>
          <p:nvPr/>
        </p:nvSpPr>
        <p:spPr>
          <a:xfrm>
            <a:off x="4032360" y="1969920"/>
            <a:ext cx="82440" cy="1876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43"/>
          <p:cNvSpPr/>
          <p:nvPr/>
        </p:nvSpPr>
        <p:spPr>
          <a:xfrm>
            <a:off x="4235400" y="1947960"/>
            <a:ext cx="82440" cy="1898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44"/>
          <p:cNvSpPr/>
          <p:nvPr/>
        </p:nvSpPr>
        <p:spPr>
          <a:xfrm>
            <a:off x="4438800" y="1844640"/>
            <a:ext cx="80640" cy="20019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145"/>
          <p:cNvSpPr/>
          <p:nvPr/>
        </p:nvSpPr>
        <p:spPr>
          <a:xfrm>
            <a:off x="4641840" y="1938240"/>
            <a:ext cx="81000" cy="1908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146"/>
          <p:cNvSpPr/>
          <p:nvPr/>
        </p:nvSpPr>
        <p:spPr>
          <a:xfrm>
            <a:off x="4843440" y="1900080"/>
            <a:ext cx="81000" cy="1946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47"/>
          <p:cNvSpPr/>
          <p:nvPr/>
        </p:nvSpPr>
        <p:spPr>
          <a:xfrm>
            <a:off x="5046840" y="2749680"/>
            <a:ext cx="82440" cy="1096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48"/>
          <p:cNvSpPr/>
          <p:nvPr/>
        </p:nvSpPr>
        <p:spPr>
          <a:xfrm>
            <a:off x="5249880" y="2822400"/>
            <a:ext cx="81000" cy="10242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149"/>
          <p:cNvSpPr/>
          <p:nvPr/>
        </p:nvSpPr>
        <p:spPr>
          <a:xfrm>
            <a:off x="5451480" y="3146400"/>
            <a:ext cx="82440" cy="7002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150"/>
          <p:cNvSpPr/>
          <p:nvPr/>
        </p:nvSpPr>
        <p:spPr>
          <a:xfrm>
            <a:off x="5654520" y="3165480"/>
            <a:ext cx="82800" cy="6811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151"/>
          <p:cNvSpPr/>
          <p:nvPr/>
        </p:nvSpPr>
        <p:spPr>
          <a:xfrm>
            <a:off x="5857920" y="3147840"/>
            <a:ext cx="82440" cy="698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152"/>
          <p:cNvSpPr/>
          <p:nvPr/>
        </p:nvSpPr>
        <p:spPr>
          <a:xfrm>
            <a:off x="1335240" y="1282680"/>
            <a:ext cx="1440" cy="2563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153"/>
          <p:cNvSpPr/>
          <p:nvPr/>
        </p:nvSpPr>
        <p:spPr>
          <a:xfrm>
            <a:off x="1298520" y="3846600"/>
            <a:ext cx="36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154"/>
          <p:cNvSpPr/>
          <p:nvPr/>
        </p:nvSpPr>
        <p:spPr>
          <a:xfrm>
            <a:off x="1298520" y="3419640"/>
            <a:ext cx="36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155"/>
          <p:cNvSpPr/>
          <p:nvPr/>
        </p:nvSpPr>
        <p:spPr>
          <a:xfrm>
            <a:off x="1298520" y="2992320"/>
            <a:ext cx="367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156"/>
          <p:cNvSpPr/>
          <p:nvPr/>
        </p:nvSpPr>
        <p:spPr>
          <a:xfrm>
            <a:off x="1298520" y="2565360"/>
            <a:ext cx="367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157"/>
          <p:cNvSpPr/>
          <p:nvPr/>
        </p:nvSpPr>
        <p:spPr>
          <a:xfrm>
            <a:off x="1298520" y="2138400"/>
            <a:ext cx="36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158"/>
          <p:cNvSpPr/>
          <p:nvPr/>
        </p:nvSpPr>
        <p:spPr>
          <a:xfrm>
            <a:off x="1298520" y="1709640"/>
            <a:ext cx="367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159"/>
          <p:cNvSpPr/>
          <p:nvPr/>
        </p:nvSpPr>
        <p:spPr>
          <a:xfrm>
            <a:off x="1273320" y="1281240"/>
            <a:ext cx="6192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160"/>
          <p:cNvSpPr/>
          <p:nvPr/>
        </p:nvSpPr>
        <p:spPr>
          <a:xfrm>
            <a:off x="1335240" y="3846600"/>
            <a:ext cx="4665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161"/>
          <p:cNvSpPr/>
          <p:nvPr/>
        </p:nvSpPr>
        <p:spPr>
          <a:xfrm flipV="1">
            <a:off x="133524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162"/>
          <p:cNvSpPr/>
          <p:nvPr/>
        </p:nvSpPr>
        <p:spPr>
          <a:xfrm flipV="1">
            <a:off x="153684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163"/>
          <p:cNvSpPr/>
          <p:nvPr/>
        </p:nvSpPr>
        <p:spPr>
          <a:xfrm flipV="1">
            <a:off x="1741320" y="3846240"/>
            <a:ext cx="180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164"/>
          <p:cNvSpPr/>
          <p:nvPr/>
        </p:nvSpPr>
        <p:spPr>
          <a:xfrm flipV="1">
            <a:off x="194328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165"/>
          <p:cNvSpPr/>
          <p:nvPr/>
        </p:nvSpPr>
        <p:spPr>
          <a:xfrm flipV="1">
            <a:off x="214632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166"/>
          <p:cNvSpPr/>
          <p:nvPr/>
        </p:nvSpPr>
        <p:spPr>
          <a:xfrm flipV="1">
            <a:off x="2349360" y="3846240"/>
            <a:ext cx="180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167"/>
          <p:cNvSpPr/>
          <p:nvPr/>
        </p:nvSpPr>
        <p:spPr>
          <a:xfrm flipV="1">
            <a:off x="255276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168"/>
          <p:cNvSpPr/>
          <p:nvPr/>
        </p:nvSpPr>
        <p:spPr>
          <a:xfrm flipV="1">
            <a:off x="275436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169"/>
          <p:cNvSpPr/>
          <p:nvPr/>
        </p:nvSpPr>
        <p:spPr>
          <a:xfrm flipV="1">
            <a:off x="2957400" y="3846240"/>
            <a:ext cx="180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170"/>
          <p:cNvSpPr/>
          <p:nvPr/>
        </p:nvSpPr>
        <p:spPr>
          <a:xfrm flipV="1">
            <a:off x="316080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171"/>
          <p:cNvSpPr/>
          <p:nvPr/>
        </p:nvSpPr>
        <p:spPr>
          <a:xfrm flipV="1">
            <a:off x="3363840" y="3846240"/>
            <a:ext cx="180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172"/>
          <p:cNvSpPr/>
          <p:nvPr/>
        </p:nvSpPr>
        <p:spPr>
          <a:xfrm flipV="1">
            <a:off x="3565440" y="3846240"/>
            <a:ext cx="180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173"/>
          <p:cNvSpPr/>
          <p:nvPr/>
        </p:nvSpPr>
        <p:spPr>
          <a:xfrm flipV="1">
            <a:off x="3770280" y="3846240"/>
            <a:ext cx="180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174"/>
          <p:cNvSpPr/>
          <p:nvPr/>
        </p:nvSpPr>
        <p:spPr>
          <a:xfrm flipV="1">
            <a:off x="3971880" y="3846240"/>
            <a:ext cx="180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175"/>
          <p:cNvSpPr/>
          <p:nvPr/>
        </p:nvSpPr>
        <p:spPr>
          <a:xfrm flipV="1">
            <a:off x="417528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176"/>
          <p:cNvSpPr/>
          <p:nvPr/>
        </p:nvSpPr>
        <p:spPr>
          <a:xfrm flipV="1">
            <a:off x="437832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177"/>
          <p:cNvSpPr/>
          <p:nvPr/>
        </p:nvSpPr>
        <p:spPr>
          <a:xfrm flipV="1">
            <a:off x="457992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178"/>
          <p:cNvSpPr/>
          <p:nvPr/>
        </p:nvSpPr>
        <p:spPr>
          <a:xfrm flipV="1">
            <a:off x="4782960" y="3846240"/>
            <a:ext cx="180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179"/>
          <p:cNvSpPr/>
          <p:nvPr/>
        </p:nvSpPr>
        <p:spPr>
          <a:xfrm flipV="1">
            <a:off x="498492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180"/>
          <p:cNvSpPr/>
          <p:nvPr/>
        </p:nvSpPr>
        <p:spPr>
          <a:xfrm flipV="1">
            <a:off x="5189400" y="3846240"/>
            <a:ext cx="180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181"/>
          <p:cNvSpPr/>
          <p:nvPr/>
        </p:nvSpPr>
        <p:spPr>
          <a:xfrm flipV="1">
            <a:off x="5391000" y="3846240"/>
            <a:ext cx="180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182"/>
          <p:cNvSpPr/>
          <p:nvPr/>
        </p:nvSpPr>
        <p:spPr>
          <a:xfrm flipV="1">
            <a:off x="559440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183"/>
          <p:cNvSpPr/>
          <p:nvPr/>
        </p:nvSpPr>
        <p:spPr>
          <a:xfrm flipV="1">
            <a:off x="5797440" y="3846240"/>
            <a:ext cx="180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184"/>
          <p:cNvSpPr/>
          <p:nvPr/>
        </p:nvSpPr>
        <p:spPr>
          <a:xfrm flipV="1">
            <a:off x="6000840" y="3846240"/>
            <a:ext cx="144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185"/>
          <p:cNvSpPr/>
          <p:nvPr/>
        </p:nvSpPr>
        <p:spPr>
          <a:xfrm>
            <a:off x="1203480" y="377496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186"/>
          <p:cNvSpPr/>
          <p:nvPr/>
        </p:nvSpPr>
        <p:spPr>
          <a:xfrm>
            <a:off x="1166760" y="334800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187"/>
          <p:cNvSpPr/>
          <p:nvPr/>
        </p:nvSpPr>
        <p:spPr>
          <a:xfrm>
            <a:off x="1166760" y="292104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188"/>
          <p:cNvSpPr/>
          <p:nvPr/>
        </p:nvSpPr>
        <p:spPr>
          <a:xfrm>
            <a:off x="1166760" y="249228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189"/>
          <p:cNvSpPr/>
          <p:nvPr/>
        </p:nvSpPr>
        <p:spPr>
          <a:xfrm>
            <a:off x="1166760" y="206532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190"/>
          <p:cNvSpPr/>
          <p:nvPr/>
        </p:nvSpPr>
        <p:spPr>
          <a:xfrm>
            <a:off x="1134360" y="16383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191"/>
          <p:cNvSpPr/>
          <p:nvPr/>
        </p:nvSpPr>
        <p:spPr>
          <a:xfrm>
            <a:off x="1134360" y="121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1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192"/>
          <p:cNvSpPr/>
          <p:nvPr/>
        </p:nvSpPr>
        <p:spPr>
          <a:xfrm>
            <a:off x="1431360" y="3943440"/>
            <a:ext cx="73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193"/>
          <p:cNvSpPr/>
          <p:nvPr/>
        </p:nvSpPr>
        <p:spPr>
          <a:xfrm>
            <a:off x="1632960" y="3943440"/>
            <a:ext cx="75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194"/>
          <p:cNvSpPr/>
          <p:nvPr/>
        </p:nvSpPr>
        <p:spPr>
          <a:xfrm>
            <a:off x="1839240" y="3943440"/>
            <a:ext cx="72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195"/>
          <p:cNvSpPr/>
          <p:nvPr/>
        </p:nvSpPr>
        <p:spPr>
          <a:xfrm>
            <a:off x="2034000" y="3943440"/>
            <a:ext cx="84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196"/>
          <p:cNvSpPr/>
          <p:nvPr/>
        </p:nvSpPr>
        <p:spPr>
          <a:xfrm>
            <a:off x="2247840" y="394344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197"/>
          <p:cNvSpPr/>
          <p:nvPr/>
        </p:nvSpPr>
        <p:spPr>
          <a:xfrm>
            <a:off x="2452680" y="3943440"/>
            <a:ext cx="60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198"/>
          <p:cNvSpPr/>
          <p:nvPr/>
        </p:nvSpPr>
        <p:spPr>
          <a:xfrm>
            <a:off x="2643840" y="3943440"/>
            <a:ext cx="84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199"/>
          <p:cNvSpPr/>
          <p:nvPr/>
        </p:nvSpPr>
        <p:spPr>
          <a:xfrm>
            <a:off x="2844360" y="3943440"/>
            <a:ext cx="86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200"/>
          <p:cNvSpPr/>
          <p:nvPr/>
        </p:nvSpPr>
        <p:spPr>
          <a:xfrm>
            <a:off x="3072960" y="3943440"/>
            <a:ext cx="3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I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201"/>
          <p:cNvSpPr/>
          <p:nvPr/>
        </p:nvSpPr>
        <p:spPr>
          <a:xfrm>
            <a:off x="3279960" y="3943440"/>
            <a:ext cx="31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J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202"/>
          <p:cNvSpPr/>
          <p:nvPr/>
        </p:nvSpPr>
        <p:spPr>
          <a:xfrm>
            <a:off x="3462480" y="3943440"/>
            <a:ext cx="7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K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203"/>
          <p:cNvSpPr/>
          <p:nvPr/>
        </p:nvSpPr>
        <p:spPr>
          <a:xfrm>
            <a:off x="3872520" y="3943440"/>
            <a:ext cx="60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204"/>
          <p:cNvSpPr/>
          <p:nvPr/>
        </p:nvSpPr>
        <p:spPr>
          <a:xfrm>
            <a:off x="4052160" y="3943440"/>
            <a:ext cx="104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205"/>
          <p:cNvSpPr/>
          <p:nvPr/>
        </p:nvSpPr>
        <p:spPr>
          <a:xfrm>
            <a:off x="4264560" y="3943440"/>
            <a:ext cx="87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206"/>
          <p:cNvSpPr/>
          <p:nvPr/>
        </p:nvSpPr>
        <p:spPr>
          <a:xfrm>
            <a:off x="4466880" y="3943440"/>
            <a:ext cx="907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207"/>
          <p:cNvSpPr/>
          <p:nvPr/>
        </p:nvSpPr>
        <p:spPr>
          <a:xfrm>
            <a:off x="4679280" y="3943440"/>
            <a:ext cx="69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208"/>
          <p:cNvSpPr/>
          <p:nvPr/>
        </p:nvSpPr>
        <p:spPr>
          <a:xfrm>
            <a:off x="4871880" y="3943440"/>
            <a:ext cx="907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Q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209"/>
          <p:cNvSpPr/>
          <p:nvPr/>
        </p:nvSpPr>
        <p:spPr>
          <a:xfrm>
            <a:off x="5084280" y="3943440"/>
            <a:ext cx="72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210"/>
          <p:cNvSpPr/>
          <p:nvPr/>
        </p:nvSpPr>
        <p:spPr>
          <a:xfrm>
            <a:off x="5291280" y="3943440"/>
            <a:ext cx="63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211"/>
          <p:cNvSpPr/>
          <p:nvPr/>
        </p:nvSpPr>
        <p:spPr>
          <a:xfrm>
            <a:off x="5492880" y="394344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212"/>
          <p:cNvSpPr/>
          <p:nvPr/>
        </p:nvSpPr>
        <p:spPr>
          <a:xfrm>
            <a:off x="5687640" y="3943440"/>
            <a:ext cx="84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U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213"/>
          <p:cNvSpPr/>
          <p:nvPr/>
        </p:nvSpPr>
        <p:spPr>
          <a:xfrm>
            <a:off x="5896080" y="3943440"/>
            <a:ext cx="69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Verdana"/>
              </a:rPr>
              <a:t>V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215"/>
          <p:cNvSpPr/>
          <p:nvPr/>
        </p:nvSpPr>
        <p:spPr>
          <a:xfrm rot="16200000">
            <a:off x="-113040" y="2502000"/>
            <a:ext cx="2026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bitrary light units x 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97"/>
          <p:cNvSpPr/>
          <p:nvPr/>
        </p:nvSpPr>
        <p:spPr>
          <a:xfrm>
            <a:off x="577800" y="4338720"/>
            <a:ext cx="8005680" cy="930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Oligonucleotides used to make the pCAG-T7-luciferase constructs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Birc5a-F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AGCTTGGTTGTCTTTTGTTTAATTTCCACACCAACCTCCCACAAAATGGATCTTGCAAGTGATGATCAGAC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Birc5a-R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CATGGTCTGATCATCACTTGCAAGATCCATTTTGTGGGAGGTTGGTGTGGAAATTAAACAAAAGACAACCA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Birc5b-F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AGCTTCACAGACGTTATCGCCTCCAGACTGCTATCCTTTAATCAGATGTATAGTTATGAAAAAAGACTTCC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Birc5b-R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CATGGGAAGTCTTTTTTCATAACTATACATCTGATTAAAGGATAGCAGTCTGGAGGCGATAACGTCTGTGA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	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12T12:21:27Z</dcterms:created>
  <dc:creator>Ed Conway</dc:creator>
  <dc:description/>
  <dc:language>en-US</dc:language>
  <cp:lastModifiedBy>Ed Conway</cp:lastModifiedBy>
  <cp:lastPrinted>2009-01-16T16:14:09Z</cp:lastPrinted>
  <dcterms:modified xsi:type="dcterms:W3CDTF">2009-04-01T17:35:14Z</dcterms:modified>
  <cp:revision>17</cp:revision>
  <dc:subject/>
  <dc:title>Slide 1</dc:title>
</cp:coreProperties>
</file>